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60" userDrawn="1">
          <p15:clr>
            <a:srgbClr val="A4A3A4"/>
          </p15:clr>
        </p15:guide>
        <p15:guide id="2" pos="288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KHG, gast" initials="Ug" lastIdx="1" clrIdx="0">
    <p:extLst>
      <p:ext uri="{19B8F6BF-5375-455C-9EA6-DF929625EA0E}">
        <p15:presenceInfo xmlns:p15="http://schemas.microsoft.com/office/powerpoint/2012/main" userId="UKHG, gast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F1CFF"/>
    <a:srgbClr val="3681C4"/>
    <a:srgbClr val="5A7FFF"/>
    <a:srgbClr val="10884C"/>
    <a:srgbClr val="0C43FF"/>
    <a:srgbClr val="FF4E5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E3FDE45-AF77-4B5C-9715-49D594BDF05E}" styleName="Helle Formatvorlage 1 - Akz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7770" autoAdjust="0"/>
    <p:restoredTop sz="94660"/>
  </p:normalViewPr>
  <p:slideViewPr>
    <p:cSldViewPr snapToGrid="0" showGuides="1">
      <p:cViewPr>
        <p:scale>
          <a:sx n="89" d="100"/>
          <a:sy n="89" d="100"/>
        </p:scale>
        <p:origin x="1770" y="180"/>
      </p:cViewPr>
      <p:guideLst>
        <p:guide orient="horz" pos="1260"/>
        <p:guide pos="28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EF864-EB0D-45D0-A56D-527F14556FB0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628C04-DE2C-451D-9575-FD15BB7CFDA2}" type="slidenum">
              <a:rPr lang="en-US" smtClean="0"/>
              <a:t>‹Nr.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-294883" y="631368"/>
            <a:ext cx="3433304" cy="1205873"/>
            <a:chOff x="-10536" y="3553240"/>
            <a:chExt cx="3555224" cy="1205873"/>
          </a:xfrm>
        </p:grpSpPr>
        <p:sp>
          <p:nvSpPr>
            <p:cNvPr id="166" name="TextBox 165"/>
            <p:cNvSpPr txBox="1"/>
            <p:nvPr/>
          </p:nvSpPr>
          <p:spPr>
            <a:xfrm>
              <a:off x="355950" y="3553240"/>
              <a:ext cx="24352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	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inigene construct overview 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-10536" y="3931777"/>
              <a:ext cx="3555224" cy="827336"/>
              <a:chOff x="473876" y="3642289"/>
              <a:chExt cx="3555224" cy="827336"/>
            </a:xfrm>
          </p:grpSpPr>
          <p:cxnSp>
            <p:nvCxnSpPr>
              <p:cNvPr id="64" name="Straight Connector 63"/>
              <p:cNvCxnSpPr/>
              <p:nvPr/>
            </p:nvCxnSpPr>
            <p:spPr>
              <a:xfrm flipV="1">
                <a:off x="2871186" y="4032071"/>
                <a:ext cx="0" cy="198000"/>
              </a:xfrm>
              <a:prstGeom prst="line">
                <a:avLst/>
              </a:prstGeom>
              <a:ln w="28575">
                <a:solidFill>
                  <a:srgbClr val="C00000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grpSp>
            <p:nvGrpSpPr>
              <p:cNvPr id="2" name="Group 1"/>
              <p:cNvGrpSpPr/>
              <p:nvPr/>
            </p:nvGrpSpPr>
            <p:grpSpPr>
              <a:xfrm>
                <a:off x="473876" y="3642289"/>
                <a:ext cx="3555224" cy="827336"/>
                <a:chOff x="473876" y="3642289"/>
                <a:chExt cx="3555224" cy="827336"/>
              </a:xfrm>
            </p:grpSpPr>
            <p:grpSp>
              <p:nvGrpSpPr>
                <p:cNvPr id="225" name="Group 224"/>
                <p:cNvGrpSpPr/>
                <p:nvPr/>
              </p:nvGrpSpPr>
              <p:grpSpPr>
                <a:xfrm>
                  <a:off x="473876" y="3642289"/>
                  <a:ext cx="3555224" cy="827336"/>
                  <a:chOff x="5799290" y="819632"/>
                  <a:chExt cx="3555224" cy="827336"/>
                </a:xfrm>
              </p:grpSpPr>
              <p:sp>
                <p:nvSpPr>
                  <p:cNvPr id="131" name="Textfeld 4"/>
                  <p:cNvSpPr txBox="1"/>
                  <p:nvPr/>
                </p:nvSpPr>
                <p:spPr>
                  <a:xfrm>
                    <a:off x="6100612" y="819632"/>
                    <a:ext cx="960960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 splicing </a:t>
                    </a:r>
                  </a:p>
                  <a:p>
                    <a:pPr algn="ctr"/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Textfeld 4"/>
                  <p:cNvSpPr txBox="1"/>
                  <p:nvPr/>
                </p:nvSpPr>
                <p:spPr>
                  <a:xfrm>
                    <a:off x="5799290" y="1308414"/>
                    <a:ext cx="158263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ariant splicing</a:t>
                    </a:r>
                  </a:p>
                  <a:p>
                    <a:pPr algn="ctr"/>
                    <a:endParaRPr lang="en-CA" sz="80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Rectangle 139"/>
                  <p:cNvSpPr/>
                  <p:nvPr/>
                </p:nvSpPr>
                <p:spPr>
                  <a:xfrm flipV="1">
                    <a:off x="6330514" y="1167607"/>
                    <a:ext cx="3024000" cy="39495"/>
                  </a:xfrm>
                  <a:prstGeom prst="rect">
                    <a:avLst/>
                  </a:prstGeom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8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Rectangle 140"/>
                  <p:cNvSpPr/>
                  <p:nvPr/>
                </p:nvSpPr>
                <p:spPr>
                  <a:xfrm>
                    <a:off x="6617524" y="1117648"/>
                    <a:ext cx="626400" cy="144000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de-DE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A</a:t>
                    </a:r>
                    <a:endPara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2" name="Rectangle 141"/>
                  <p:cNvSpPr/>
                  <p:nvPr/>
                </p:nvSpPr>
                <p:spPr>
                  <a:xfrm>
                    <a:off x="7742665" y="1117648"/>
                    <a:ext cx="396000" cy="144000"/>
                  </a:xfrm>
                  <a:prstGeom prst="rect">
                    <a:avLst/>
                  </a:prstGeom>
                  <a:solidFill>
                    <a:srgbClr val="D9D9D9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144" name="TextBox 143"/>
                  <p:cNvSpPr txBox="1"/>
                  <p:nvPr/>
                </p:nvSpPr>
                <p:spPr>
                  <a:xfrm>
                    <a:off x="7815610" y="1374357"/>
                    <a:ext cx="83708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.</a:t>
                    </a:r>
                    <a:r>
                      <a:rPr lang="en-US" altLang="de-DE" sz="8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05+2T&gt;C</a:t>
                    </a:r>
                  </a:p>
                </p:txBody>
              </p:sp>
              <p:sp>
                <p:nvSpPr>
                  <p:cNvPr id="145" name="Rectangle 144"/>
                  <p:cNvSpPr/>
                  <p:nvPr/>
                </p:nvSpPr>
                <p:spPr>
                  <a:xfrm>
                    <a:off x="8639105" y="1113838"/>
                    <a:ext cx="626400" cy="144000"/>
                  </a:xfrm>
                  <a:prstGeom prst="rect">
                    <a:avLst/>
                  </a:prstGeom>
                  <a:ln>
                    <a:prstDash val="soli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de-DE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B</a:t>
                    </a:r>
                    <a:endPara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83" name="Straight Connector 182"/>
                  <p:cNvCxnSpPr/>
                  <p:nvPr/>
                </p:nvCxnSpPr>
                <p:spPr>
                  <a:xfrm flipH="1">
                    <a:off x="7241304" y="985905"/>
                    <a:ext cx="247534" cy="130201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Straight Connector 183"/>
                  <p:cNvCxnSpPr/>
                  <p:nvPr/>
                </p:nvCxnSpPr>
                <p:spPr>
                  <a:xfrm>
                    <a:off x="7490471" y="985093"/>
                    <a:ext cx="247534" cy="130201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5" name="Straight Connector 184"/>
                  <p:cNvCxnSpPr/>
                  <p:nvPr/>
                </p:nvCxnSpPr>
                <p:spPr>
                  <a:xfrm flipH="1">
                    <a:off x="8143811" y="985217"/>
                    <a:ext cx="247534" cy="130201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6" name="Straight Connector 185"/>
                  <p:cNvCxnSpPr/>
                  <p:nvPr/>
                </p:nvCxnSpPr>
                <p:spPr>
                  <a:xfrm>
                    <a:off x="8387431" y="983639"/>
                    <a:ext cx="247534" cy="130201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7" name="Straight Connector 186"/>
                  <p:cNvCxnSpPr/>
                  <p:nvPr/>
                </p:nvCxnSpPr>
                <p:spPr>
                  <a:xfrm flipH="1" flipV="1">
                    <a:off x="7251267" y="1268008"/>
                    <a:ext cx="687600" cy="8425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Straight Connector 187"/>
                  <p:cNvCxnSpPr/>
                  <p:nvPr/>
                </p:nvCxnSpPr>
                <p:spPr>
                  <a:xfrm flipV="1">
                    <a:off x="7936359" y="1268885"/>
                    <a:ext cx="699239" cy="8425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4" name="Straight Connector 73"/>
                <p:cNvCxnSpPr/>
                <p:nvPr/>
              </p:nvCxnSpPr>
              <p:spPr>
                <a:xfrm flipH="1" flipV="1">
                  <a:off x="2638484" y="3694611"/>
                  <a:ext cx="669676" cy="250402"/>
                </a:xfrm>
                <a:prstGeom prst="line">
                  <a:avLst/>
                </a:prstGeom>
                <a:ln w="6350">
                  <a:prstDash val="sysDash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Straight Connector 75"/>
                <p:cNvCxnSpPr/>
                <p:nvPr/>
              </p:nvCxnSpPr>
              <p:spPr>
                <a:xfrm flipH="1">
                  <a:off x="1918636" y="3696923"/>
                  <a:ext cx="719848" cy="251713"/>
                </a:xfrm>
                <a:prstGeom prst="line">
                  <a:avLst/>
                </a:prstGeom>
                <a:ln w="6350">
                  <a:prstDash val="sysDash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8" name="Group 7"/>
          <p:cNvGrpSpPr/>
          <p:nvPr/>
        </p:nvGrpSpPr>
        <p:grpSpPr>
          <a:xfrm>
            <a:off x="3077324" y="20320"/>
            <a:ext cx="3641578" cy="2380494"/>
            <a:chOff x="-108741" y="88153"/>
            <a:chExt cx="5325247" cy="3256831"/>
          </a:xfrm>
        </p:grpSpPr>
        <p:sp>
          <p:nvSpPr>
            <p:cNvPr id="63" name="TextBox 62"/>
            <p:cNvSpPr txBox="1"/>
            <p:nvPr/>
          </p:nvSpPr>
          <p:spPr>
            <a:xfrm>
              <a:off x="-15151" y="221889"/>
              <a:ext cx="2372763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	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-PCR gel electrophoresis 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feld 4"/>
            <p:cNvSpPr txBox="1"/>
            <p:nvPr/>
          </p:nvSpPr>
          <p:spPr>
            <a:xfrm rot="18660000">
              <a:off x="461948" y="880396"/>
              <a:ext cx="1617118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x12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6" name="Textfeld 6"/>
            <p:cNvSpPr txBox="1"/>
            <p:nvPr/>
          </p:nvSpPr>
          <p:spPr>
            <a:xfrm rot="18660000">
              <a:off x="812059" y="819896"/>
              <a:ext cx="1745585" cy="31505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  <a:r>
                <a:rPr lang="en-US" alt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205T&gt;C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67" name="Textfeld 4"/>
            <p:cNvSpPr txBox="1"/>
            <p:nvPr/>
          </p:nvSpPr>
          <p:spPr>
            <a:xfrm rot="18660000">
              <a:off x="183375" y="1144447"/>
              <a:ext cx="943093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size ladder</a:t>
              </a:r>
            </a:p>
          </p:txBody>
        </p:sp>
        <p:sp>
          <p:nvSpPr>
            <p:cNvPr id="68" name="Textfeld 11"/>
            <p:cNvSpPr txBox="1"/>
            <p:nvPr/>
          </p:nvSpPr>
          <p:spPr>
            <a:xfrm>
              <a:off x="-71033" y="1381684"/>
              <a:ext cx="494906" cy="294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feld 14"/>
            <p:cNvSpPr txBox="1"/>
            <p:nvPr/>
          </p:nvSpPr>
          <p:spPr>
            <a:xfrm>
              <a:off x="-104742" y="2576011"/>
              <a:ext cx="781551" cy="2526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feld 16"/>
            <p:cNvSpPr txBox="1"/>
            <p:nvPr/>
          </p:nvSpPr>
          <p:spPr>
            <a:xfrm>
              <a:off x="-89652" y="2321816"/>
              <a:ext cx="734600" cy="2526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feld 14"/>
            <p:cNvSpPr txBox="1"/>
            <p:nvPr/>
          </p:nvSpPr>
          <p:spPr>
            <a:xfrm>
              <a:off x="-104742" y="2438518"/>
              <a:ext cx="571626" cy="2526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feld 14"/>
            <p:cNvSpPr txBox="1"/>
            <p:nvPr/>
          </p:nvSpPr>
          <p:spPr>
            <a:xfrm>
              <a:off x="-108741" y="2732753"/>
              <a:ext cx="903188" cy="2526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feld 6"/>
            <p:cNvSpPr txBox="1"/>
            <p:nvPr/>
          </p:nvSpPr>
          <p:spPr>
            <a:xfrm rot="18660000">
              <a:off x="1185958" y="969720"/>
              <a:ext cx="1364793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feld 4"/>
            <p:cNvSpPr txBox="1"/>
            <p:nvPr/>
          </p:nvSpPr>
          <p:spPr>
            <a:xfrm rot="18660000">
              <a:off x="1827258" y="940595"/>
              <a:ext cx="1409974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PCR neg.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feld 4"/>
            <p:cNvSpPr txBox="1"/>
            <p:nvPr/>
          </p:nvSpPr>
          <p:spPr>
            <a:xfrm rot="18660000">
              <a:off x="1470039" y="847491"/>
              <a:ext cx="1702479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Transfection neg.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r="8530"/>
            <a:stretch/>
          </p:blipFill>
          <p:spPr>
            <a:xfrm>
              <a:off x="2784727" y="1594022"/>
              <a:ext cx="2122360" cy="1556190"/>
            </a:xfrm>
            <a:prstGeom prst="rect">
              <a:avLst/>
            </a:prstGeom>
          </p:spPr>
        </p:pic>
        <p:sp>
          <p:nvSpPr>
            <p:cNvPr id="56" name="Textfeld 4"/>
            <p:cNvSpPr txBox="1"/>
            <p:nvPr/>
          </p:nvSpPr>
          <p:spPr>
            <a:xfrm rot="18660000">
              <a:off x="2968918" y="871809"/>
              <a:ext cx="1617118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x12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7" name="Textfeld 6"/>
            <p:cNvSpPr txBox="1"/>
            <p:nvPr/>
          </p:nvSpPr>
          <p:spPr>
            <a:xfrm rot="18660000">
              <a:off x="3334492" y="825769"/>
              <a:ext cx="1745585" cy="31505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c.</a:t>
              </a:r>
              <a:r>
                <a:rPr lang="en-US" alt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205T&gt;C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8" name="Textfeld 4"/>
            <p:cNvSpPr txBox="1"/>
            <p:nvPr/>
          </p:nvSpPr>
          <p:spPr>
            <a:xfrm rot="18660000">
              <a:off x="2682615" y="1135859"/>
              <a:ext cx="943093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size ladder</a:t>
              </a:r>
            </a:p>
          </p:txBody>
        </p:sp>
        <p:sp>
          <p:nvSpPr>
            <p:cNvPr id="59" name="Textfeld 11"/>
            <p:cNvSpPr txBox="1"/>
            <p:nvPr/>
          </p:nvSpPr>
          <p:spPr>
            <a:xfrm>
              <a:off x="2405273" y="1375976"/>
              <a:ext cx="514053" cy="294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6"/>
            <p:cNvSpPr txBox="1"/>
            <p:nvPr/>
          </p:nvSpPr>
          <p:spPr>
            <a:xfrm rot="18660000">
              <a:off x="3747041" y="961131"/>
              <a:ext cx="1364793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feld 4"/>
            <p:cNvSpPr txBox="1"/>
            <p:nvPr/>
          </p:nvSpPr>
          <p:spPr>
            <a:xfrm rot="18660000">
              <a:off x="4403797" y="939240"/>
              <a:ext cx="1409974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PCR neg.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4"/>
            <p:cNvSpPr txBox="1"/>
            <p:nvPr/>
          </p:nvSpPr>
          <p:spPr>
            <a:xfrm rot="18660000">
              <a:off x="4054309" y="831670"/>
              <a:ext cx="1702479" cy="21544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Transfection neg.</a:t>
              </a:r>
              <a:endParaRPr lang="en-CA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612530" y="3113887"/>
              <a:ext cx="9765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CT116 cell line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161141" y="3129540"/>
              <a:ext cx="10454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K293T cell line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6186" y="1596483"/>
              <a:ext cx="2020487" cy="1551188"/>
            </a:xfrm>
            <a:prstGeom prst="rect">
              <a:avLst/>
            </a:prstGeom>
          </p:spPr>
        </p:pic>
        <p:sp>
          <p:nvSpPr>
            <p:cNvPr id="45" name="Textfeld 14"/>
            <p:cNvSpPr txBox="1"/>
            <p:nvPr/>
          </p:nvSpPr>
          <p:spPr>
            <a:xfrm>
              <a:off x="2400792" y="2541067"/>
              <a:ext cx="555800" cy="252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16"/>
            <p:cNvSpPr txBox="1"/>
            <p:nvPr/>
          </p:nvSpPr>
          <p:spPr>
            <a:xfrm>
              <a:off x="2435418" y="2272801"/>
              <a:ext cx="656605" cy="252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14"/>
            <p:cNvSpPr txBox="1"/>
            <p:nvPr/>
          </p:nvSpPr>
          <p:spPr>
            <a:xfrm>
              <a:off x="2418607" y="2391633"/>
              <a:ext cx="555800" cy="252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14"/>
            <p:cNvSpPr txBox="1"/>
            <p:nvPr/>
          </p:nvSpPr>
          <p:spPr>
            <a:xfrm>
              <a:off x="2401085" y="2673556"/>
              <a:ext cx="673437" cy="252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en-CA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90989" y="238480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948780" y="2581274"/>
              <a:ext cx="4568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304057" y="2558968"/>
              <a:ext cx="4568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610115" y="2598799"/>
              <a:ext cx="4568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114296" y="2522991"/>
              <a:ext cx="4568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3496654" y="2522991"/>
              <a:ext cx="4568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889361" y="2522991"/>
              <a:ext cx="4568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114088" y="2341925"/>
              <a:ext cx="4568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4" name="TextBox 103"/>
          <p:cNvSpPr txBox="1"/>
          <p:nvPr/>
        </p:nvSpPr>
        <p:spPr>
          <a:xfrm>
            <a:off x="86260" y="4021078"/>
            <a:ext cx="29594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ragment analysis electropherogram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7B245B7A-86B3-6118-596E-87D02CA832C3}"/>
              </a:ext>
            </a:extLst>
          </p:cNvPr>
          <p:cNvGrpSpPr/>
          <p:nvPr/>
        </p:nvGrpSpPr>
        <p:grpSpPr>
          <a:xfrm>
            <a:off x="118852" y="2244512"/>
            <a:ext cx="5011595" cy="1597127"/>
            <a:chOff x="-66722" y="3210077"/>
            <a:chExt cx="5011595" cy="1597127"/>
          </a:xfrm>
        </p:grpSpPr>
        <p:sp>
          <p:nvSpPr>
            <p:cNvPr id="72" name="TextBox 71"/>
            <p:cNvSpPr txBox="1"/>
            <p:nvPr/>
          </p:nvSpPr>
          <p:spPr>
            <a:xfrm>
              <a:off x="-66722" y="3210077"/>
              <a:ext cx="239039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de-DE" sz="2400" dirty="0">
                  <a:latin typeface="Arial" panose="020B0604020202020204" pitchFamily="34" charset="0"/>
                  <a:cs typeface="Arial" panose="020B0604020202020204" pitchFamily="34" charset="0"/>
                </a:rPr>
                <a:t>	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T-PCR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roduct</a:t>
              </a:r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sequencing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Gruppieren 10">
              <a:extLst>
                <a:ext uri="{FF2B5EF4-FFF2-40B4-BE49-F238E27FC236}">
                  <a16:creationId xmlns:a16="http://schemas.microsoft.com/office/drawing/2014/main" id="{8A78F10D-C2EB-4FA5-319E-9A2EA04D0DF1}"/>
                </a:ext>
              </a:extLst>
            </p:cNvPr>
            <p:cNvGrpSpPr/>
            <p:nvPr/>
          </p:nvGrpSpPr>
          <p:grpSpPr>
            <a:xfrm>
              <a:off x="218266" y="3675993"/>
              <a:ext cx="2521559" cy="1131211"/>
              <a:chOff x="218266" y="3675993"/>
              <a:chExt cx="2521559" cy="1131211"/>
            </a:xfrm>
          </p:grpSpPr>
          <p:pic>
            <p:nvPicPr>
              <p:cNvPr id="84" name="Picture 83"/>
              <p:cNvPicPr>
                <a:picLocks noChangeAspect="1"/>
              </p:cNvPicPr>
              <p:nvPr/>
            </p:nvPicPr>
            <p:blipFill rotWithShape="1">
              <a:blip r:embed="rId4"/>
              <a:srcRect l="37220" t="21738" r="40081"/>
              <a:stretch/>
            </p:blipFill>
            <p:spPr>
              <a:xfrm>
                <a:off x="1446555" y="4284568"/>
                <a:ext cx="1008859" cy="486673"/>
              </a:xfrm>
              <a:prstGeom prst="rect">
                <a:avLst/>
              </a:prstGeom>
            </p:spPr>
          </p:pic>
          <p:pic>
            <p:nvPicPr>
              <p:cNvPr id="85" name="Picture 84"/>
              <p:cNvPicPr>
                <a:picLocks noChangeAspect="1"/>
              </p:cNvPicPr>
              <p:nvPr/>
            </p:nvPicPr>
            <p:blipFill rotWithShape="1">
              <a:blip r:embed="rId5"/>
              <a:srcRect l="37722" t="13785" r="39806" b="679"/>
              <a:stretch/>
            </p:blipFill>
            <p:spPr>
              <a:xfrm>
                <a:off x="331569" y="4214812"/>
                <a:ext cx="1048850" cy="558807"/>
              </a:xfrm>
              <a:prstGeom prst="rect">
                <a:avLst/>
              </a:prstGeom>
            </p:spPr>
          </p:pic>
          <p:cxnSp>
            <p:nvCxnSpPr>
              <p:cNvPr id="93" name="Straight Connector 92"/>
              <p:cNvCxnSpPr>
                <a:cxnSpLocks noChangeAspect="1"/>
              </p:cNvCxnSpPr>
              <p:nvPr/>
            </p:nvCxnSpPr>
            <p:spPr>
              <a:xfrm flipH="1">
                <a:off x="1367860" y="4702561"/>
                <a:ext cx="59069" cy="102466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4" name="Rechteck 3">
                <a:extLst>
                  <a:ext uri="{FF2B5EF4-FFF2-40B4-BE49-F238E27FC236}">
                    <a16:creationId xmlns:a16="http://schemas.microsoft.com/office/drawing/2014/main" id="{D3BEB97F-8114-84B2-73B1-CB0B3AFDF922}"/>
                  </a:ext>
                </a:extLst>
              </p:cNvPr>
              <p:cNvSpPr/>
              <p:nvPr/>
            </p:nvSpPr>
            <p:spPr>
              <a:xfrm>
                <a:off x="304356" y="3869165"/>
                <a:ext cx="547777" cy="231069"/>
              </a:xfrm>
              <a:prstGeom prst="rect">
                <a:avLst/>
              </a:prstGeom>
              <a:solidFill>
                <a:srgbClr val="FF1C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CA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on A</a:t>
                </a:r>
              </a:p>
              <a:p>
                <a:pPr algn="ctr"/>
                <a:r>
                  <a:rPr lang="de-DE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80 bp</a:t>
                </a:r>
                <a:endParaRPr lang="en-CA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hteck 3">
                <a:extLst>
                  <a:ext uri="{FF2B5EF4-FFF2-40B4-BE49-F238E27FC236}">
                    <a16:creationId xmlns:a16="http://schemas.microsoft.com/office/drawing/2014/main" id="{8C1FBB14-6BAF-011E-F679-775FF5D6A783}"/>
                  </a:ext>
                </a:extLst>
              </p:cNvPr>
              <p:cNvSpPr/>
              <p:nvPr/>
            </p:nvSpPr>
            <p:spPr>
              <a:xfrm>
                <a:off x="1969026" y="3869102"/>
                <a:ext cx="504778" cy="230400"/>
              </a:xfrm>
              <a:prstGeom prst="rect">
                <a:avLst/>
              </a:prstGeom>
              <a:solidFill>
                <a:srgbClr val="FF1C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CA" sz="7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on B</a:t>
                </a:r>
              </a:p>
              <a:p>
                <a:pPr algn="ctr"/>
                <a:r>
                  <a:rPr lang="de-DE" sz="7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6 bp</a:t>
                </a:r>
                <a:endParaRPr lang="en-CA" sz="7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hteck 14">
                <a:extLst>
                  <a:ext uri="{FF2B5EF4-FFF2-40B4-BE49-F238E27FC236}">
                    <a16:creationId xmlns:a16="http://schemas.microsoft.com/office/drawing/2014/main" id="{D8F7224C-7302-97E2-A2AC-B3272E50FE07}"/>
                  </a:ext>
                </a:extLst>
              </p:cNvPr>
              <p:cNvSpPr/>
              <p:nvPr/>
            </p:nvSpPr>
            <p:spPr>
              <a:xfrm>
                <a:off x="850866" y="3869101"/>
                <a:ext cx="1118159" cy="231131"/>
              </a:xfrm>
              <a:prstGeom prst="rect">
                <a:avLst/>
              </a:prstGeom>
              <a:solidFill>
                <a:srgbClr val="3681C4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CA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on 12</a:t>
                </a:r>
              </a:p>
              <a:p>
                <a:pPr algn="ctr"/>
                <a:r>
                  <a:rPr lang="de-DE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60 bp</a:t>
                </a:r>
                <a:endParaRPr lang="en-CA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218266" y="4089990"/>
                <a:ext cx="1522695" cy="1973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de-DE" sz="8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8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  <a:r>
                  <a:rPr lang="de-DE" sz="8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800" b="1" dirty="0">
                    <a:solidFill>
                      <a:srgbClr val="10884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800" dirty="0">
                    <a:solidFill>
                      <a:srgbClr val="10884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G </a:t>
                </a:r>
                <a:r>
                  <a:rPr lang="de-DE" sz="800" dirty="0">
                    <a:solidFill>
                      <a:srgbClr val="0C4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800" dirty="0">
                    <a:solidFill>
                      <a:srgbClr val="10884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A </a:t>
                </a:r>
                <a:r>
                  <a:rPr lang="de-DE" sz="800" dirty="0">
                    <a:solidFill>
                      <a:srgbClr val="0C4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</a:t>
                </a:r>
                <a:endParaRPr lang="en-US" sz="8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1357414" y="4089990"/>
                <a:ext cx="1382411" cy="1973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800" dirty="0">
                    <a:solidFill>
                      <a:srgbClr val="10884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A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 G G</a:t>
                </a:r>
                <a:r>
                  <a:rPr lang="de-DE" sz="800" dirty="0">
                    <a:solidFill>
                      <a:srgbClr val="FF4E5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8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8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  <a:r>
                  <a:rPr lang="de-DE" sz="8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8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8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9" name="Straight Connector 98"/>
              <p:cNvCxnSpPr>
                <a:cxnSpLocks noChangeAspect="1"/>
              </p:cNvCxnSpPr>
              <p:nvPr/>
            </p:nvCxnSpPr>
            <p:spPr>
              <a:xfrm flipH="1">
                <a:off x="1421933" y="4704738"/>
                <a:ext cx="59069" cy="102466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>
                <a:cxnSpLocks noChangeAspect="1"/>
              </p:cNvCxnSpPr>
              <p:nvPr/>
            </p:nvCxnSpPr>
            <p:spPr>
              <a:xfrm>
                <a:off x="848755" y="4130942"/>
                <a:ext cx="0" cy="612525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>
                <a:cxnSpLocks noChangeAspect="1"/>
              </p:cNvCxnSpPr>
              <p:nvPr/>
            </p:nvCxnSpPr>
            <p:spPr>
              <a:xfrm>
                <a:off x="1965445" y="4130942"/>
                <a:ext cx="0" cy="610353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102" name="TextBox 101"/>
              <p:cNvSpPr txBox="1"/>
              <p:nvPr/>
            </p:nvSpPr>
            <p:spPr>
              <a:xfrm>
                <a:off x="843064" y="3675993"/>
                <a:ext cx="1322809" cy="3171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Low">
                  <a:lnSpc>
                    <a:spcPct val="107000"/>
                  </a:lnSpc>
                </a:pPr>
                <a:r>
                  <a:rPr lang="en-GB" sz="8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ET01</a:t>
                </a:r>
                <a:r>
                  <a:rPr lang="en-GB" sz="800" i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OTOF </a:t>
                </a:r>
                <a:r>
                  <a:rPr lang="en-GB" sz="8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xon 12 WT</a:t>
                </a:r>
              </a:p>
              <a:p>
                <a:pPr algn="justLow">
                  <a:lnSpc>
                    <a:spcPct val="107000"/>
                  </a:lnSpc>
                  <a:spcAft>
                    <a:spcPts val="0"/>
                  </a:spcAft>
                </a:pPr>
                <a:endParaRPr lang="en-GB" sz="8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785932" y="4204143"/>
                <a:ext cx="803154" cy="1973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8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  <a:r>
                  <a:rPr lang="de-DE" sz="8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8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8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2407955" y="3893030"/>
              <a:ext cx="6319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406 bp</a:t>
              </a:r>
            </a:p>
          </p:txBody>
        </p:sp>
        <p:grpSp>
          <p:nvGrpSpPr>
            <p:cNvPr id="10" name="Gruppieren 9">
              <a:extLst>
                <a:ext uri="{FF2B5EF4-FFF2-40B4-BE49-F238E27FC236}">
                  <a16:creationId xmlns:a16="http://schemas.microsoft.com/office/drawing/2014/main" id="{E2A8A95D-79C0-6957-9CC1-6C6B877ACA89}"/>
                </a:ext>
              </a:extLst>
            </p:cNvPr>
            <p:cNvGrpSpPr/>
            <p:nvPr/>
          </p:nvGrpSpPr>
          <p:grpSpPr>
            <a:xfrm>
              <a:off x="3029921" y="3694630"/>
              <a:ext cx="1914952" cy="1081574"/>
              <a:chOff x="3215383" y="3689666"/>
              <a:chExt cx="1914952" cy="1081574"/>
            </a:xfrm>
          </p:grpSpPr>
          <p:pic>
            <p:nvPicPr>
              <p:cNvPr id="86" name="Picture 85"/>
              <p:cNvPicPr>
                <a:picLocks noChangeAspect="1"/>
              </p:cNvPicPr>
              <p:nvPr/>
            </p:nvPicPr>
            <p:blipFill rotWithShape="1">
              <a:blip r:embed="rId6"/>
              <a:srcRect l="37504" t="17561" r="39862"/>
              <a:stretch/>
            </p:blipFill>
            <p:spPr>
              <a:xfrm>
                <a:off x="3541775" y="4264144"/>
                <a:ext cx="1024459" cy="507096"/>
              </a:xfrm>
              <a:prstGeom prst="rect">
                <a:avLst/>
              </a:prstGeom>
            </p:spPr>
          </p:pic>
          <p:sp>
            <p:nvSpPr>
              <p:cNvPr id="87" name="Rechteck 3">
                <a:extLst>
                  <a:ext uri="{FF2B5EF4-FFF2-40B4-BE49-F238E27FC236}">
                    <a16:creationId xmlns:a16="http://schemas.microsoft.com/office/drawing/2014/main" id="{D3BEB97F-8114-84B2-73B1-CB0B3AFDF922}"/>
                  </a:ext>
                </a:extLst>
              </p:cNvPr>
              <p:cNvSpPr/>
              <p:nvPr/>
            </p:nvSpPr>
            <p:spPr>
              <a:xfrm>
                <a:off x="3507129" y="3870266"/>
                <a:ext cx="547777" cy="231070"/>
              </a:xfrm>
              <a:prstGeom prst="rect">
                <a:avLst/>
              </a:prstGeom>
              <a:solidFill>
                <a:srgbClr val="FF1C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CA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on A</a:t>
                </a:r>
              </a:p>
              <a:p>
                <a:pPr algn="ctr"/>
                <a:r>
                  <a:rPr lang="de-DE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80 bp</a:t>
                </a:r>
                <a:endParaRPr lang="en-CA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Rechteck 3">
                <a:extLst>
                  <a:ext uri="{FF2B5EF4-FFF2-40B4-BE49-F238E27FC236}">
                    <a16:creationId xmlns:a16="http://schemas.microsoft.com/office/drawing/2014/main" id="{8C1FBB14-6BAF-011E-F679-775FF5D6A783}"/>
                  </a:ext>
                </a:extLst>
              </p:cNvPr>
              <p:cNvSpPr/>
              <p:nvPr/>
            </p:nvSpPr>
            <p:spPr>
              <a:xfrm>
                <a:off x="4053950" y="3870266"/>
                <a:ext cx="504155" cy="230400"/>
              </a:xfrm>
              <a:prstGeom prst="rect">
                <a:avLst/>
              </a:prstGeom>
              <a:solidFill>
                <a:srgbClr val="FF1C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CA" sz="7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on B</a:t>
                </a:r>
              </a:p>
              <a:p>
                <a:pPr algn="ctr"/>
                <a:r>
                  <a:rPr lang="de-DE" sz="7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6 bp</a:t>
                </a:r>
                <a:endParaRPr lang="en-CA" sz="7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3437437" y="4091217"/>
                <a:ext cx="899769" cy="1973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de-DE" sz="8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8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  <a:r>
                  <a:rPr lang="de-DE" sz="8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lang="en-US" sz="8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3997032" y="4094655"/>
                <a:ext cx="803154" cy="1973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8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  <a:r>
                  <a:rPr lang="de-DE" sz="8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8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8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1" name="Straight Connector 90"/>
              <p:cNvCxnSpPr>
                <a:cxnSpLocks noChangeAspect="1"/>
              </p:cNvCxnSpPr>
              <p:nvPr/>
            </p:nvCxnSpPr>
            <p:spPr>
              <a:xfrm>
                <a:off x="4052191" y="4099916"/>
                <a:ext cx="0" cy="612525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92" name="TextBox 91"/>
              <p:cNvSpPr txBox="1"/>
              <p:nvPr/>
            </p:nvSpPr>
            <p:spPr>
              <a:xfrm>
                <a:off x="3215383" y="3689666"/>
                <a:ext cx="1765679" cy="3171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Low">
                  <a:lnSpc>
                    <a:spcPct val="107000"/>
                  </a:lnSpc>
                </a:pPr>
                <a:r>
                  <a:rPr lang="en-GB" sz="8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ET01 </a:t>
                </a:r>
                <a:r>
                  <a:rPr lang="en-GB" sz="800" i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TOF </a:t>
                </a:r>
                <a:r>
                  <a:rPr lang="en-GB" sz="8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xon 12 c.1205+2T&gt;C</a:t>
                </a:r>
              </a:p>
              <a:p>
                <a:pPr algn="justLow">
                  <a:lnSpc>
                    <a:spcPct val="107000"/>
                  </a:lnSpc>
                  <a:spcAft>
                    <a:spcPts val="0"/>
                  </a:spcAft>
                </a:pPr>
                <a:endParaRPr lang="en-GB" sz="8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3">
                <a:extLst>
                  <a:ext uri="{FF2B5EF4-FFF2-40B4-BE49-F238E27FC236}">
                    <a16:creationId xmlns:a16="http://schemas.microsoft.com/office/drawing/2014/main" id="{1EAD1A0E-BB7D-4D34-A792-BDF6CB673287}"/>
                  </a:ext>
                </a:extLst>
              </p:cNvPr>
              <p:cNvSpPr txBox="1"/>
              <p:nvPr/>
            </p:nvSpPr>
            <p:spPr>
              <a:xfrm>
                <a:off x="4498431" y="3881923"/>
                <a:ext cx="6319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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246 bp</a:t>
                </a:r>
              </a:p>
            </p:txBody>
          </p:sp>
        </p:grpSp>
      </p:grpSp>
      <p:grpSp>
        <p:nvGrpSpPr>
          <p:cNvPr id="22" name="Gruppieren 21">
            <a:extLst>
              <a:ext uri="{FF2B5EF4-FFF2-40B4-BE49-F238E27FC236}">
                <a16:creationId xmlns:a16="http://schemas.microsoft.com/office/drawing/2014/main" id="{DA5C15B7-CEC4-6265-29DD-2FA6A4C82900}"/>
              </a:ext>
            </a:extLst>
          </p:cNvPr>
          <p:cNvGrpSpPr/>
          <p:nvPr/>
        </p:nvGrpSpPr>
        <p:grpSpPr>
          <a:xfrm>
            <a:off x="260977" y="4533191"/>
            <a:ext cx="3093249" cy="2502350"/>
            <a:chOff x="303264" y="6521192"/>
            <a:chExt cx="5786251" cy="3950125"/>
          </a:xfrm>
        </p:grpSpPr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CA7E084F-D2D4-4790-70E2-AD0E7769334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0715" y="6900700"/>
              <a:ext cx="5676162" cy="1395861"/>
            </a:xfrm>
            <a:prstGeom prst="rect">
              <a:avLst/>
            </a:prstGeom>
          </p:spPr>
        </p:pic>
        <p:pic>
          <p:nvPicPr>
            <p:cNvPr id="15" name="Grafik 14">
              <a:extLst>
                <a:ext uri="{FF2B5EF4-FFF2-40B4-BE49-F238E27FC236}">
                  <a16:creationId xmlns:a16="http://schemas.microsoft.com/office/drawing/2014/main" id="{578BCC6B-8CBC-9253-AD30-177E613FD3E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r="108"/>
            <a:stretch/>
          </p:blipFill>
          <p:spPr>
            <a:xfrm>
              <a:off x="303264" y="9082163"/>
              <a:ext cx="5786251" cy="1389154"/>
            </a:xfrm>
            <a:prstGeom prst="rect">
              <a:avLst/>
            </a:prstGeom>
          </p:spPr>
        </p:pic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9D1D9C8E-0558-15D8-0F72-05240937E10B}"/>
                </a:ext>
              </a:extLst>
            </p:cNvPr>
            <p:cNvSpPr txBox="1"/>
            <p:nvPr/>
          </p:nvSpPr>
          <p:spPr>
            <a:xfrm>
              <a:off x="482161" y="6521192"/>
              <a:ext cx="888072" cy="3030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xon 12 WT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71969BA4-2362-8990-19D0-E11008286CC9}"/>
                </a:ext>
              </a:extLst>
            </p:cNvPr>
            <p:cNvSpPr txBox="1"/>
            <p:nvPr/>
          </p:nvSpPr>
          <p:spPr>
            <a:xfrm>
              <a:off x="433894" y="8697070"/>
              <a:ext cx="1580662" cy="3030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Exon 12 c.1205+2T&gt;C</a:t>
              </a:r>
            </a:p>
          </p:txBody>
        </p:sp>
        <p:sp>
          <p:nvSpPr>
            <p:cNvPr id="19" name="Pfeil nach rechts 18">
              <a:extLst>
                <a:ext uri="{FF2B5EF4-FFF2-40B4-BE49-F238E27FC236}">
                  <a16:creationId xmlns:a16="http://schemas.microsoft.com/office/drawing/2014/main" id="{4D4A30E9-E8F0-F083-D13B-0793494810F2}"/>
                </a:ext>
              </a:extLst>
            </p:cNvPr>
            <p:cNvSpPr/>
            <p:nvPr/>
          </p:nvSpPr>
          <p:spPr>
            <a:xfrm rot="5400000">
              <a:off x="1875495" y="7492890"/>
              <a:ext cx="151181" cy="146199"/>
            </a:xfrm>
            <a:prstGeom prst="rightArrow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20" name="Pfeil nach rechts 19">
              <a:extLst>
                <a:ext uri="{FF2B5EF4-FFF2-40B4-BE49-F238E27FC236}">
                  <a16:creationId xmlns:a16="http://schemas.microsoft.com/office/drawing/2014/main" id="{059B878E-73FC-E7DB-B7C8-E1AF54F5AC1F}"/>
                </a:ext>
              </a:extLst>
            </p:cNvPr>
            <p:cNvSpPr/>
            <p:nvPr/>
          </p:nvSpPr>
          <p:spPr>
            <a:xfrm rot="5400000">
              <a:off x="1875495" y="8983485"/>
              <a:ext cx="151181" cy="146199"/>
            </a:xfrm>
            <a:prstGeom prst="rightArrow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21" name="Pfeil nach rechts 20">
              <a:extLst>
                <a:ext uri="{FF2B5EF4-FFF2-40B4-BE49-F238E27FC236}">
                  <a16:creationId xmlns:a16="http://schemas.microsoft.com/office/drawing/2014/main" id="{69D5E890-F3D1-DB47-4E28-B45A42F3B2DB}"/>
                </a:ext>
              </a:extLst>
            </p:cNvPr>
            <p:cNvSpPr/>
            <p:nvPr/>
          </p:nvSpPr>
          <p:spPr>
            <a:xfrm rot="5400000">
              <a:off x="2777693" y="6667989"/>
              <a:ext cx="151181" cy="146199"/>
            </a:xfrm>
            <a:prstGeom prst="rightArrow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  <p:sp>
        <p:nvSpPr>
          <p:cNvPr id="105" name="TextBox 103">
            <a:extLst>
              <a:ext uri="{FF2B5EF4-FFF2-40B4-BE49-F238E27FC236}">
                <a16:creationId xmlns:a16="http://schemas.microsoft.com/office/drawing/2014/main" id="{6BCA7E18-C45D-4CC2-80F1-1C6F5DE242BD}"/>
              </a:ext>
            </a:extLst>
          </p:cNvPr>
          <p:cNvSpPr txBox="1"/>
          <p:nvPr/>
        </p:nvSpPr>
        <p:spPr>
          <a:xfrm>
            <a:off x="3377986" y="4075389"/>
            <a:ext cx="22333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Fragment analysis value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8">
            <a:extLst>
              <a:ext uri="{FF2B5EF4-FFF2-40B4-BE49-F238E27FC236}">
                <a16:creationId xmlns:a16="http://schemas.microsoft.com/office/drawing/2014/main" id="{87E2D930-47BA-4DC2-B7D6-CD6F69827828}"/>
              </a:ext>
            </a:extLst>
          </p:cNvPr>
          <p:cNvSpPr txBox="1"/>
          <p:nvPr/>
        </p:nvSpPr>
        <p:spPr>
          <a:xfrm>
            <a:off x="187874" y="7616061"/>
            <a:ext cx="6499350" cy="18466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gure S2</a:t>
            </a:r>
            <a:r>
              <a:rPr lang="en-US" sz="9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: Minigene assay of the c.1205+2T&gt;C </a:t>
            </a:r>
            <a:r>
              <a:rPr lang="en-US" sz="900" i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TOF</a:t>
            </a:r>
            <a:r>
              <a:rPr lang="en-US" sz="9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variant. (A) Minigene construct schematic with exon 12 of </a:t>
            </a:r>
            <a:r>
              <a:rPr lang="en-US" sz="900" i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TOF </a:t>
            </a:r>
            <a:r>
              <a:rPr lang="en-US" sz="9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loned in between exon A and B of the vector. The red arrow displays the position of the variant. The WT and variant construct splicing pattern is indicated on top and bottom, respectively. (B) Final RT-PCR products with controls after gel electrophoresis. Minigenes were transfected into HCT116 (left) and HEK293T (right) cells. (C) Direct Sanger sequencing results of WT and variant final RT-PCR products of HCT116 cells. The primer PCR 02 F, aligning to exon A of pET01 was used as a primer for sequencing. Exon A and B of the vector are indicated by pink boxes, exon 12 by a blue box. The wild-type construct sample shows a mixture of normal exon 12 splicing and skipping of exon 12. The variant sample shows exon 12 skipping only. (D) Electropherogram of the final RT-PCR product derived from HCT116 cells. </a:t>
            </a:r>
            <a:r>
              <a:rPr lang="en-US" sz="9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rrows indicate peaks of 246 bp and 406 bp. </a:t>
            </a:r>
            <a:r>
              <a:rPr lang="en-US" sz="9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E) Fragment analysis peak results of FAM-labeled RT-PCR products. Only peaks &gt; 200 RFU </a:t>
            </a:r>
            <a:r>
              <a:rPr lang="en-US" sz="9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f height between 245-1000 bp, which are present in all three triplicates were considered. </a:t>
            </a:r>
            <a:r>
              <a:rPr lang="en-US" sz="9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The size and area under the curve (AUC) of the peaks at the same base pair</a:t>
            </a:r>
            <a:r>
              <a:rPr lang="en-US" sz="9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-</a:t>
            </a:r>
            <a:r>
              <a:rPr lang="en-US" sz="9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length of triplicate</a:t>
            </a:r>
            <a:r>
              <a:rPr lang="en-US" sz="9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samples were averaged. Wild-type expression of exon 12 was completely abolished in the variant, with the potential consequence on RNA and protein listed.</a:t>
            </a:r>
            <a:endParaRPr lang="de-DE" sz="9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r>
              <a:rPr lang="en-US" sz="6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 </a:t>
            </a:r>
            <a:endParaRPr lang="de-DE" sz="6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sp>
        <p:nvSpPr>
          <p:cNvPr id="108" name="Textfeld 1">
            <a:extLst>
              <a:ext uri="{FF2B5EF4-FFF2-40B4-BE49-F238E27FC236}">
                <a16:creationId xmlns:a16="http://schemas.microsoft.com/office/drawing/2014/main" id="{5876B0A4-E932-AE70-4BC6-8DC1039AAADC}"/>
              </a:ext>
            </a:extLst>
          </p:cNvPr>
          <p:cNvSpPr txBox="1"/>
          <p:nvPr/>
        </p:nvSpPr>
        <p:spPr>
          <a:xfrm>
            <a:off x="3500609" y="4529253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12 WT</a:t>
            </a:r>
          </a:p>
        </p:txBody>
      </p:sp>
      <p:sp>
        <p:nvSpPr>
          <p:cNvPr id="109" name="Textfeld 2">
            <a:extLst>
              <a:ext uri="{FF2B5EF4-FFF2-40B4-BE49-F238E27FC236}">
                <a16:creationId xmlns:a16="http://schemas.microsoft.com/office/drawing/2014/main" id="{F5F7AED6-0D36-41A5-FBA5-516B712035C3}"/>
              </a:ext>
            </a:extLst>
          </p:cNvPr>
          <p:cNvSpPr txBox="1"/>
          <p:nvPr/>
        </p:nvSpPr>
        <p:spPr>
          <a:xfrm>
            <a:off x="3536356" y="5902898"/>
            <a:ext cx="1217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12 c.1205+2T&gt;C</a:t>
            </a:r>
          </a:p>
        </p:txBody>
      </p:sp>
      <p:graphicFrame>
        <p:nvGraphicFramePr>
          <p:cNvPr id="110" name="Tabelle 15">
            <a:extLst>
              <a:ext uri="{FF2B5EF4-FFF2-40B4-BE49-F238E27FC236}">
                <a16:creationId xmlns:a16="http://schemas.microsoft.com/office/drawing/2014/main" id="{60B347E8-18F2-4233-3A29-6D3F56F131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4673414"/>
              </p:ext>
            </p:extLst>
          </p:nvPr>
        </p:nvGraphicFramePr>
        <p:xfrm>
          <a:off x="3500609" y="4744697"/>
          <a:ext cx="2555383" cy="1163955"/>
        </p:xfrm>
        <a:graphic>
          <a:graphicData uri="http://schemas.openxmlformats.org/drawingml/2006/table">
            <a:tbl>
              <a:tblPr/>
              <a:tblGrid>
                <a:gridCol w="327014">
                  <a:extLst>
                    <a:ext uri="{9D8B030D-6E8A-4147-A177-3AD203B41FA5}">
                      <a16:colId xmlns:a16="http://schemas.microsoft.com/office/drawing/2014/main" val="1151917723"/>
                    </a:ext>
                  </a:extLst>
                </a:gridCol>
                <a:gridCol w="476410">
                  <a:extLst>
                    <a:ext uri="{9D8B030D-6E8A-4147-A177-3AD203B41FA5}">
                      <a16:colId xmlns:a16="http://schemas.microsoft.com/office/drawing/2014/main" val="131161844"/>
                    </a:ext>
                  </a:extLst>
                </a:gridCol>
                <a:gridCol w="476410">
                  <a:extLst>
                    <a:ext uri="{9D8B030D-6E8A-4147-A177-3AD203B41FA5}">
                      <a16:colId xmlns:a16="http://schemas.microsoft.com/office/drawing/2014/main" val="1913915239"/>
                    </a:ext>
                  </a:extLst>
                </a:gridCol>
                <a:gridCol w="591670">
                  <a:extLst>
                    <a:ext uri="{9D8B030D-6E8A-4147-A177-3AD203B41FA5}">
                      <a16:colId xmlns:a16="http://schemas.microsoft.com/office/drawing/2014/main" val="640297113"/>
                    </a:ext>
                  </a:extLst>
                </a:gridCol>
                <a:gridCol w="683879">
                  <a:extLst>
                    <a:ext uri="{9D8B030D-6E8A-4147-A177-3AD203B41FA5}">
                      <a16:colId xmlns:a16="http://schemas.microsoft.com/office/drawing/2014/main" val="88738738"/>
                    </a:ext>
                  </a:extLst>
                </a:gridCol>
              </a:tblGrid>
              <a:tr h="218477"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ctual size (bp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UC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ing pattern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00865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116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5441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839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8"/>
                          <a:cs typeface="Arial" panose="020B0604020202020204" pitchFamily="34" charset="0"/>
                        </a:rPr>
                        <a:t>17</a:t>
                      </a:r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2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3822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88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6537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5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9429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9077890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K293T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51461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873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2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4742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28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71985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4.9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1337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06924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6.6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11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1878233"/>
                  </a:ext>
                </a:extLst>
              </a:tr>
            </a:tbl>
          </a:graphicData>
        </a:graphic>
      </p:graphicFrame>
      <p:graphicFrame>
        <p:nvGraphicFramePr>
          <p:cNvPr id="111" name="Tabelle 9">
            <a:extLst>
              <a:ext uri="{FF2B5EF4-FFF2-40B4-BE49-F238E27FC236}">
                <a16:creationId xmlns:a16="http://schemas.microsoft.com/office/drawing/2014/main" id="{E3D0F477-E70D-88D4-3978-95C97C51D7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8109978"/>
              </p:ext>
            </p:extLst>
          </p:nvPr>
        </p:nvGraphicFramePr>
        <p:xfrm>
          <a:off x="3498211" y="6096488"/>
          <a:ext cx="3168698" cy="1163956"/>
        </p:xfrm>
        <a:graphic>
          <a:graphicData uri="http://schemas.openxmlformats.org/drawingml/2006/table">
            <a:tbl>
              <a:tblPr/>
              <a:tblGrid>
                <a:gridCol w="315502">
                  <a:extLst>
                    <a:ext uri="{9D8B030D-6E8A-4147-A177-3AD203B41FA5}">
                      <a16:colId xmlns:a16="http://schemas.microsoft.com/office/drawing/2014/main" val="1151917723"/>
                    </a:ext>
                  </a:extLst>
                </a:gridCol>
                <a:gridCol w="379832">
                  <a:extLst>
                    <a:ext uri="{9D8B030D-6E8A-4147-A177-3AD203B41FA5}">
                      <a16:colId xmlns:a16="http://schemas.microsoft.com/office/drawing/2014/main" val="2293644315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944641791"/>
                    </a:ext>
                  </a:extLst>
                </a:gridCol>
                <a:gridCol w="638302">
                  <a:extLst>
                    <a:ext uri="{9D8B030D-6E8A-4147-A177-3AD203B41FA5}">
                      <a16:colId xmlns:a16="http://schemas.microsoft.com/office/drawing/2014/main" val="4165301244"/>
                    </a:ext>
                  </a:extLst>
                </a:gridCol>
                <a:gridCol w="600776">
                  <a:extLst>
                    <a:ext uri="{9D8B030D-6E8A-4147-A177-3AD203B41FA5}">
                      <a16:colId xmlns:a16="http://schemas.microsoft.com/office/drawing/2014/main" val="4127366300"/>
                    </a:ext>
                  </a:extLst>
                </a:gridCol>
                <a:gridCol w="777086">
                  <a:extLst>
                    <a:ext uri="{9D8B030D-6E8A-4147-A177-3AD203B41FA5}">
                      <a16:colId xmlns:a16="http://schemas.microsoft.com/office/drawing/2014/main" val="1918292064"/>
                    </a:ext>
                  </a:extLst>
                </a:gridCol>
              </a:tblGrid>
              <a:tr h="387984"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ctual size (bp)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UC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ing pattern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equence </a:t>
                      </a:r>
                      <a:endParaRPr lang="de-DE" sz="6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00865"/>
                  </a:ext>
                </a:extLst>
              </a:tr>
              <a:tr h="96997">
                <a:tc gridSpan="6"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116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544182"/>
                  </a:ext>
                </a:extLst>
              </a:tr>
              <a:tr h="10710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5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4944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  <a:endParaRPr lang="de-DE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2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</a:t>
                      </a:r>
                      <a:r>
                        <a:rPr lang="en-US" sz="6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en-US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(1046_1205del),</a:t>
                      </a:r>
                      <a:r>
                        <a:rPr lang="en-US" sz="600" b="0" i="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(Glu349Glyfs*20)</a:t>
                      </a:r>
                      <a:endParaRPr lang="de-DE" sz="6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382290"/>
                  </a:ext>
                </a:extLst>
              </a:tr>
              <a:tr h="183889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39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 fontAlgn="b"/>
                      <a:endParaRPr lang="de-DE" sz="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653785"/>
                  </a:ext>
                </a:extLst>
              </a:tr>
              <a:tr h="96997">
                <a:tc gridSpan="6"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K293T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5146123"/>
                  </a:ext>
                </a:extLst>
              </a:tr>
              <a:tr h="10710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7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2691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12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</a:t>
                      </a:r>
                      <a:r>
                        <a:rPr lang="en-US" sz="6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 r</a:t>
                      </a:r>
                      <a:r>
                        <a:rPr lang="en-US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(1046_1205del),</a:t>
                      </a:r>
                      <a:r>
                        <a:rPr lang="en-US" sz="600" b="0" i="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(Glu349Glyfs*20)</a:t>
                      </a:r>
                      <a:endParaRPr lang="de-DE" sz="6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474221"/>
                  </a:ext>
                </a:extLst>
              </a:tr>
              <a:tr h="183889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382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 fontAlgn="b"/>
                      <a:endParaRPr lang="de-DE" sz="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71985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77367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8</Words>
  <Application>Microsoft Office PowerPoint</Application>
  <PresentationFormat>A4-Papier (210 x 297 mm)</PresentationFormat>
  <Paragraphs>13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9" baseType="lpstr">
      <vt:lpstr>Arial</vt:lpstr>
      <vt:lpstr>Arial Unicode MS</vt:lpstr>
      <vt:lpstr>Calibri</vt:lpstr>
      <vt:lpstr>Calibri Light</vt:lpstr>
      <vt:lpstr>Cambria</vt:lpstr>
      <vt:lpstr>MS Mincho</vt:lpstr>
      <vt:lpstr>Wingdings</vt:lpstr>
      <vt:lpstr>Office Theme</vt:lpstr>
      <vt:lpstr>PowerPoint-Präsentation</vt:lpstr>
    </vt:vector>
  </TitlesOfParts>
  <Company>Universitätsmedizin Gött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wrang, Daniel</dc:creator>
  <cp:lastModifiedBy>Vona, Barbara</cp:lastModifiedBy>
  <cp:revision>179</cp:revision>
  <dcterms:created xsi:type="dcterms:W3CDTF">2023-12-07T18:39:00Z</dcterms:created>
  <dcterms:modified xsi:type="dcterms:W3CDTF">2025-02-02T11:00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13F21B9EDBC4E86A2724BBEE1A9C62A_12</vt:lpwstr>
  </property>
  <property fmtid="{D5CDD505-2E9C-101B-9397-08002B2CF9AE}" pid="3" name="KSOProductBuildVer">
    <vt:lpwstr>1033-12.2.0.17119</vt:lpwstr>
  </property>
</Properties>
</file>